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3" autoAdjust="0"/>
    <p:restoredTop sz="94660"/>
  </p:normalViewPr>
  <p:slideViewPr>
    <p:cSldViewPr snapToGrid="0">
      <p:cViewPr varScale="1">
        <p:scale>
          <a:sx n="68" d="100"/>
          <a:sy n="68" d="100"/>
        </p:scale>
        <p:origin x="25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627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27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23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545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157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11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2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010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330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463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845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82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10316" y="4419600"/>
            <a:ext cx="54864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S1 Fig. Anti-FITC responses are similar in EcoHIV-infected and control mice</a:t>
            </a:r>
            <a:r>
              <a:rPr lang="en-US" sz="1200" dirty="0">
                <a:latin typeface="Arial" panose="020B0604020202020204" pitchFamily="34" charset="0"/>
                <a:cs typeface="Arial" pitchFamily="34" charset="0"/>
              </a:rPr>
              <a:t>. Four mice each were injected with EcoHIV or PBS; one month later mice were immunized by IP injection with E coli cells labeled with FITC. Mice were bled from the retro-orbital sinus before EcoHIV or PBS injection and at 10 and 17 days after immunization. Anti-FITC antibody response in 1:20 fold diluted sera was measured by Elisa with plates coated with ovalbumin FITC.  Data presented are net OD after subtraction of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reble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values, each point represents one mouse.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1809750" y="1304925"/>
          <a:ext cx="2817813" cy="2081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SPW 12.0 Graph" r:id="rId3" imgW="4696809" imgH="3468478" progId="SigmaPlotGraphicObject.11">
                  <p:embed/>
                </p:oleObj>
              </mc:Choice>
              <mc:Fallback>
                <p:oleObj name="SPW 12.0 Graph" r:id="rId3" imgW="4696809" imgH="3468478" progId="SigmaPlotGraphicObject.11">
                  <p:embed/>
                  <p:pic>
                    <p:nvPicPr>
                      <p:cNvPr id="4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09750" y="1304925"/>
                        <a:ext cx="2817813" cy="20812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82088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8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PW 12.0 Graph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Volsky</dc:creator>
  <cp:lastModifiedBy>David Volsky</cp:lastModifiedBy>
  <cp:revision>1</cp:revision>
  <dcterms:created xsi:type="dcterms:W3CDTF">2018-05-11T18:35:20Z</dcterms:created>
  <dcterms:modified xsi:type="dcterms:W3CDTF">2018-05-11T18:35:48Z</dcterms:modified>
</cp:coreProperties>
</file>